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embeddings/oleObject2.xlsx" ContentType="application/vnd.openxmlformats-officedocument.spreadsheetml.sheet"/>
  <Override PartName="/ppt/media/image1.wmf" ContentType="image/x-wmf"/>
  <Override PartName="/ppt/media/image2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56DBE8-6EC7-4AB8-9A3F-6959A3F64F3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4F1FBE-C5AB-4910-869A-CAA4E74A7F6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C131F6-3D90-44A9-8533-CDFB0AB4929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F52077-2653-47C8-9816-CC784E76A3E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B96291-90A0-4E95-A965-C1043C8D944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9B11EF-D131-4E26-B119-B21A847C810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94DD25-B23F-43EF-A4C7-95D57E89CDF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07278D-28FE-45DF-9914-14B6F6E5D12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E42D46-5C16-475F-900D-41855B955D8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E59C18-E72F-4312-BFB1-CEA2C1F11E6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5873A9-60E3-4551-9490-27268B65A92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791C2D-8664-4C91-AB48-0ABB0D43960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8808163-9B3C-46D3-9B18-DCD786930B6F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wmf"/><Relationship Id="rId3" Type="http://schemas.openxmlformats.org/officeDocument/2006/relationships/package" Target="../embeddings/oleObject2.xlsx"/><Relationship Id="rId4" Type="http://schemas.openxmlformats.org/officeDocument/2006/relationships/image" Target="../media/image2.wmf"/><Relationship Id="rId5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1052640" y="755640"/>
          <a:ext cx="5133960" cy="323388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42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052640" y="755640"/>
                    <a:ext cx="5133960" cy="32338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3" name=""/>
          <p:cNvGraphicFramePr/>
          <p:nvPr/>
        </p:nvGraphicFramePr>
        <p:xfrm>
          <a:off x="1052640" y="4508640"/>
          <a:ext cx="5133960" cy="3233520"/>
        </p:xfrm>
        <a:graphic>
          <a:graphicData uri="http://schemas.openxmlformats.org/presentationml/2006/ole">
            <p:oleObj progId="Excel.Sheet.12" r:id="rId3" spid="">
              <p:embed/>
              <p:pic>
                <p:nvPicPr>
                  <p:cNvPr id="44" name="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1052640" y="4508640"/>
                    <a:ext cx="5133960" cy="32335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5" name=""/>
          <p:cNvSpPr/>
          <p:nvPr/>
        </p:nvSpPr>
        <p:spPr>
          <a:xfrm>
            <a:off x="2426760" y="3780000"/>
            <a:ext cx="2474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Specie’s order numbe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2325240" y="7589880"/>
            <a:ext cx="2474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Specie’s order numbe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 rot="10800000">
            <a:off x="764640" y="1001520"/>
            <a:ext cx="454680" cy="2273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# Sequence Domain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 rot="10800000">
            <a:off x="764640" y="4744800"/>
            <a:ext cx="454680" cy="2273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# Sequence Domain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446760" y="611280"/>
            <a:ext cx="4003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4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438840" y="4421160"/>
            <a:ext cx="4003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4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4653000" y="2411280"/>
            <a:ext cx="71280" cy="649440"/>
          </a:xfrm>
          <a:custGeom>
            <a:avLst/>
            <a:gdLst>
              <a:gd name="textAreaLeft" fmla="*/ 0 w 71280"/>
              <a:gd name="textAreaRight" fmla="*/ 50040 w 71280"/>
              <a:gd name="textAreaTop" fmla="*/ 27000 h 649440"/>
              <a:gd name="textAreaBottom" fmla="*/ 622440 h 6494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10800" y="0"/>
                  <a:pt x="21600" y="900"/>
                  <a:pt x="21600" y="1800"/>
                </a:cubicBezTo>
                <a:lnTo>
                  <a:pt x="21600" y="19800"/>
                </a:lnTo>
                <a:cubicBezTo>
                  <a:pt x="21600" y="20700"/>
                  <a:pt x="108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2083320" y="2849400"/>
            <a:ext cx="1005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Group 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4799520" y="2543040"/>
            <a:ext cx="1005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Group 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3897720" y="1173240"/>
            <a:ext cx="1005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Group 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1856880" y="1166760"/>
            <a:ext cx="1410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Arial"/>
              </a:rPr>
              <a:t>Eukaryot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1776240" y="4932360"/>
            <a:ext cx="1499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Arial"/>
              </a:rPr>
              <a:t>Prokaryot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2331000" y="8335800"/>
            <a:ext cx="2678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Supplementary Figure  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10-11T10:47:20Z</dcterms:created>
  <dc:creator>ucbcja0</dc:creator>
  <dc:description/>
  <dc:language>en-US</dc:language>
  <cp:lastModifiedBy>ucbcja0</cp:lastModifiedBy>
  <dcterms:modified xsi:type="dcterms:W3CDTF">2007-06-08T14:00:24Z</dcterms:modified>
  <cp:revision>11</cp:revision>
  <dc:subject/>
  <dc:title>Slide 1</dc:title>
</cp:coreProperties>
</file>